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6" r:id="rId3"/>
    <p:sldId id="268" r:id="rId4"/>
    <p:sldId id="269" r:id="rId5"/>
    <p:sldId id="27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9" d="100"/>
          <a:sy n="99" d="100"/>
        </p:scale>
        <p:origin x="90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A8960-0848-BDF8-D1C7-210740058E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D44165D-5AB0-C3A1-279A-9D20064821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6E9605-D100-7496-16EE-BD2905439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AF0C9-A189-453C-78EE-59616E914B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BDD9C2-07D1-843B-A9BA-96C73CAA8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607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B54BC-6D81-53E5-26E1-BE8499F99D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A44308-6D54-1F8A-D0A7-1E261201B6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1FD73-2E91-C5AC-5603-F8820BBA5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4FD9B7-1756-3FDE-D319-17169A48A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761235-0077-0778-7909-E21BFD02EF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377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E2D683-554D-C4E3-B781-C70F5205F0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64D2CD-BD17-B9D9-2DF6-557B1821E3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31EFE1-93DB-9183-EBBB-5174D28FA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883D46-118F-B6C8-E81A-B212C04E6F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253A2-7E5D-647A-3747-014CC79F51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7075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B56F86-9195-D48A-E0D1-4F6BCBD1D2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FF5E81-63CF-2B47-9656-91CA642784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6ED2A7-D7D4-241C-8274-9143ABD7E4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0D3B72-0F39-CA17-0B78-9A644F993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24DCBD-4EE3-FC17-D336-B63969FAC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2346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A337CE-1B9F-246B-43C6-41E3BE615C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D2A861-7CC8-FC66-0B2F-2F79D6D119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5AD94E-892E-6F63-242F-3A72F9418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0441B8-85A9-5AA3-6356-A6C74FFF9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F34197-0CD3-CE7E-174C-3AD974C82C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89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C87984-830C-CAA7-F182-50E543C31E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343F11-C0FF-F20C-1E3E-69E7C7592D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762088-99E8-FD93-6A06-2F8EEF2D8F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D512A9-E9C7-3F31-2244-346EFD0F96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0CE16E-D683-7314-2255-1E2D4D0CA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8B1560-6319-B840-4FF8-A1624620D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914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E1FA3-934E-F46F-6CD6-8E771D618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32D244-8549-59DF-269D-360DAD2E65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4E8D98-2DCB-6A8D-8D58-C25F3C3876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B50FC09-86AB-6987-089E-86006A66D6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30932C-C786-C5F5-DFDD-39268679A33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CF2481-6E22-9513-5D7A-9A7E9513F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D3BC65-1D1B-107D-F917-5212CD727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D7FD58-250D-549A-BF0C-0E352F004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19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8EE8C-2514-627F-824E-C3D38DCD89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82577D-C5E8-0D56-CBE8-5D40C98DF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3D71BE-36E6-BA0D-C1C1-BF3043614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E45BE8-6069-4410-1561-CECE7747C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19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8E6DD4-CB47-A3D7-F2E0-6C078508E2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C9D7F5A-922E-CB5E-DE69-1B23793E8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F531D4-8466-AB5D-4470-C0FE5DA55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830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8A9E93-7576-4F25-E9BC-1F6D58A738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715716-9391-194F-FB14-95E0487C9F2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05F2F3-6D98-9CB7-A26F-BEF84A65E6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42E84C-B19B-DC5B-22C0-1A17A597C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D18039-DDA1-F47E-8648-7E0604139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54360B-4123-AEC5-3FC6-53A89F002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425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9A9C7D-EF2F-9759-F1A0-26DC9B8A34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48CA15-0769-E768-A8DB-D3C8DE5053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E4D097-0C0A-002C-7100-3A425941FC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4543B8-7DEC-AFD0-E025-BEF748952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F050F7-9A28-3761-0B26-6ADEBCA29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6B7111-B154-5C15-D3B3-CD3514FBA5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735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46A5E20-629D-C4F2-B33D-DF610E8CA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C2C9C2-2A51-01EF-34F5-88927BF609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61278C-EFD0-8C45-DF9A-5E58105878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E0497-5B34-4C1B-9441-CBE03C096E44}" type="datetimeFigureOut">
              <a:rPr lang="en-US" smtClean="0"/>
              <a:t>6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7AF44A-097A-096F-DA85-03D9C61F59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D62294-3FD9-1C05-2DC7-1FD0BB4D17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AD9BC2-54A5-40CF-99F1-568C404490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110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92697D35-BA72-7ADD-91CD-2B90C5772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ardiac CT: thickened neo-aortic valve leaflets with limited systolic opening.  The neo-aortic graft is 18 mm in diameter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838B457-8DCA-8124-A87E-8AAE523AF76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210" t="21465" r="30586" b="24643"/>
          <a:stretch/>
        </p:blipFill>
        <p:spPr>
          <a:xfrm>
            <a:off x="838200" y="2174032"/>
            <a:ext cx="5326187" cy="431884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08008F8-D77D-4EAB-1BD1-F380550C06A7}"/>
              </a:ext>
            </a:extLst>
          </p:cNvPr>
          <p:cNvSpPr txBox="1"/>
          <p:nvPr/>
        </p:nvSpPr>
        <p:spPr>
          <a:xfrm>
            <a:off x="4434540" y="2826258"/>
            <a:ext cx="1716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eo-aortic valv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0B6CFF-6544-94AE-119A-F1EF92971C2E}"/>
              </a:ext>
            </a:extLst>
          </p:cNvPr>
          <p:cNvSpPr txBox="1"/>
          <p:nvPr/>
        </p:nvSpPr>
        <p:spPr>
          <a:xfrm>
            <a:off x="989245" y="2782669"/>
            <a:ext cx="84234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ative </a:t>
            </a:r>
          </a:p>
          <a:p>
            <a:r>
              <a:rPr lang="en-US" dirty="0">
                <a:solidFill>
                  <a:schemeClr val="bg1"/>
                </a:solidFill>
              </a:rPr>
              <a:t>aorta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27920156-5260-43CD-BC2B-9CAD04BE2958}"/>
              </a:ext>
            </a:extLst>
          </p:cNvPr>
          <p:cNvCxnSpPr>
            <a:cxnSpLocks/>
            <a:stCxn id="9" idx="1"/>
          </p:cNvCxnSpPr>
          <p:nvPr/>
        </p:nvCxnSpPr>
        <p:spPr>
          <a:xfrm flipH="1">
            <a:off x="4051883" y="3010924"/>
            <a:ext cx="382657" cy="17658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57F355FA-665B-0659-655F-71CE8530BE07}"/>
              </a:ext>
            </a:extLst>
          </p:cNvPr>
          <p:cNvCxnSpPr>
            <a:cxnSpLocks/>
          </p:cNvCxnSpPr>
          <p:nvPr/>
        </p:nvCxnSpPr>
        <p:spPr>
          <a:xfrm>
            <a:off x="1594975" y="3195590"/>
            <a:ext cx="871388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79BD8716-FA35-3DD4-20A8-9B5021E50DB4}"/>
              </a:ext>
            </a:extLst>
          </p:cNvPr>
          <p:cNvSpPr txBox="1"/>
          <p:nvPr/>
        </p:nvSpPr>
        <p:spPr>
          <a:xfrm>
            <a:off x="3968103" y="2440482"/>
            <a:ext cx="1675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Neo-aortic graft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59BF31BF-AE9F-DD81-9B4B-C787778DE4B0}"/>
              </a:ext>
            </a:extLst>
          </p:cNvPr>
          <p:cNvCxnSpPr>
            <a:cxnSpLocks/>
          </p:cNvCxnSpPr>
          <p:nvPr/>
        </p:nvCxnSpPr>
        <p:spPr>
          <a:xfrm flipH="1">
            <a:off x="3776774" y="2694376"/>
            <a:ext cx="382657" cy="17658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269D9125-8D2D-2A85-E57B-F0734F4D1C49}"/>
              </a:ext>
            </a:extLst>
          </p:cNvPr>
          <p:cNvSpPr txBox="1"/>
          <p:nvPr/>
        </p:nvSpPr>
        <p:spPr>
          <a:xfrm>
            <a:off x="3000600" y="5713384"/>
            <a:ext cx="155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Right Ventricle</a:t>
            </a:r>
          </a:p>
        </p:txBody>
      </p: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AEAC571-867B-CB54-9A39-2F45D89D686C}"/>
              </a:ext>
            </a:extLst>
          </p:cNvPr>
          <p:cNvCxnSpPr>
            <a:cxnSpLocks/>
            <a:stCxn id="19" idx="0"/>
          </p:cNvCxnSpPr>
          <p:nvPr/>
        </p:nvCxnSpPr>
        <p:spPr>
          <a:xfrm flipV="1">
            <a:off x="3776774" y="4480504"/>
            <a:ext cx="191328" cy="123288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B6415C4A-37F2-EED1-45CE-C064B1EAE635}"/>
              </a:ext>
            </a:extLst>
          </p:cNvPr>
          <p:cNvSpPr txBox="1"/>
          <p:nvPr/>
        </p:nvSpPr>
        <p:spPr>
          <a:xfrm>
            <a:off x="4354967" y="3571775"/>
            <a:ext cx="1875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Thickened leaflets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FBD74D51-74F4-FDC7-5710-798D864187D5}"/>
              </a:ext>
            </a:extLst>
          </p:cNvPr>
          <p:cNvCxnSpPr>
            <a:cxnSpLocks/>
            <a:stCxn id="2" idx="1"/>
          </p:cNvCxnSpPr>
          <p:nvPr/>
        </p:nvCxnSpPr>
        <p:spPr>
          <a:xfrm flipH="1" flipV="1">
            <a:off x="3666033" y="3590560"/>
            <a:ext cx="688934" cy="165881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4615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9352F8-10BE-6C65-8FE5-FD0119915D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Catheterization: Aortogram Showing </a:t>
            </a:r>
            <a:r>
              <a:rPr lang="en-US" dirty="0" err="1"/>
              <a:t>Hemashield</a:t>
            </a:r>
            <a:r>
              <a:rPr lang="en-US" dirty="0"/>
              <a:t> Neo-Aortic Graft that Measures 15-17 mm and Thickened Neo-Aortic Valve Leaflets </a:t>
            </a:r>
          </a:p>
        </p:txBody>
      </p:sp>
      <p:pic>
        <p:nvPicPr>
          <p:cNvPr id="4" name="Picture 3" descr="An x-ray of a heart&#10;&#10;AI-generated content may be incorrect.">
            <a:extLst>
              <a:ext uri="{FF2B5EF4-FFF2-40B4-BE49-F238E27FC236}">
                <a16:creationId xmlns:a16="http://schemas.microsoft.com/office/drawing/2014/main" id="{A7C5FE4C-FF16-45F6-E458-5EF35151F4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2566" y="1918208"/>
            <a:ext cx="5206867" cy="4855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60337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CA065-1052-89EA-7E2F-8516271940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Catheterization: Intervention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2F952CED-F165-E964-2676-C0184B571DB4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US" dirty="0"/>
              <a:t>A Palmaz 3110 bare metal stent was crimped on outside of Melody Valve on the 22 mm delivery ensemble and advanced via right femoral artery</a:t>
            </a:r>
          </a:p>
          <a:p>
            <a:r>
              <a:rPr lang="en-US" dirty="0"/>
              <a:t>Aortic sighting injection with a pigtail via the left femoral artery before valve expansion. </a:t>
            </a:r>
          </a:p>
          <a:p>
            <a:r>
              <a:rPr lang="en-US" dirty="0"/>
              <a:t>We aimed to anchor the valve in the neo-aortic graft, but extend proximally enough to pin the abnormal neo-aortic valve leaflets</a:t>
            </a:r>
          </a:p>
        </p:txBody>
      </p:sp>
      <p:sp>
        <p:nvSpPr>
          <p:cNvPr id="8" name="Content Placeholder 7">
            <a:extLst>
              <a:ext uri="{FF2B5EF4-FFF2-40B4-BE49-F238E27FC236}">
                <a16:creationId xmlns:a16="http://schemas.microsoft.com/office/drawing/2014/main" id="{E9172817-37A4-B068-8D91-66706B3002EC}"/>
              </a:ext>
            </a:extLst>
          </p:cNvPr>
          <p:cNvSpPr>
            <a:spLocks noGrp="1"/>
          </p:cNvSpPr>
          <p:nvPr>
            <p:ph sz="half" idx="2"/>
          </p:nvPr>
        </p:nvSpPr>
        <p:spPr/>
        <p:txBody>
          <a:bodyPr>
            <a:normAutofit fontScale="92500" lnSpcReduction="10000"/>
          </a:bodyPr>
          <a:lstStyle/>
          <a:p>
            <a:endParaRPr lang="en-US"/>
          </a:p>
        </p:txBody>
      </p:sp>
      <p:pic>
        <p:nvPicPr>
          <p:cNvPr id="4" name="Picture 3" descr="An x-ray of a heart&#10;&#10;AI-generated content may be incorrect.">
            <a:extLst>
              <a:ext uri="{FF2B5EF4-FFF2-40B4-BE49-F238E27FC236}">
                <a16:creationId xmlns:a16="http://schemas.microsoft.com/office/drawing/2014/main" id="{F631F77A-69EC-B2B7-F9FF-8A58E51716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4476" y="1549865"/>
            <a:ext cx="4959324" cy="494301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5682FFB-767C-0219-233A-CD88ED50C388}"/>
              </a:ext>
            </a:extLst>
          </p:cNvPr>
          <p:cNvSpPr txBox="1"/>
          <p:nvPr/>
        </p:nvSpPr>
        <p:spPr>
          <a:xfrm>
            <a:off x="9453408" y="4740940"/>
            <a:ext cx="19003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arrot at end of</a:t>
            </a:r>
          </a:p>
          <a:p>
            <a:r>
              <a:rPr lang="en-US" dirty="0">
                <a:solidFill>
                  <a:schemeClr val="bg1"/>
                </a:solidFill>
              </a:rPr>
              <a:t>delivery ensembl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6B553E-C89C-2C61-C72D-429C626F02C3}"/>
              </a:ext>
            </a:extLst>
          </p:cNvPr>
          <p:cNvSpPr txBox="1"/>
          <p:nvPr/>
        </p:nvSpPr>
        <p:spPr>
          <a:xfrm>
            <a:off x="6862608" y="5508688"/>
            <a:ext cx="1172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afari wire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26733F2F-0859-DF70-A05D-6E48A5D037D4}"/>
              </a:ext>
            </a:extLst>
          </p:cNvPr>
          <p:cNvCxnSpPr>
            <a:cxnSpLocks/>
          </p:cNvCxnSpPr>
          <p:nvPr/>
        </p:nvCxnSpPr>
        <p:spPr>
          <a:xfrm flipH="1" flipV="1">
            <a:off x="8992175" y="4621912"/>
            <a:ext cx="536836" cy="26772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FD075A48-6435-3DD2-69B3-094FC393DCFC}"/>
              </a:ext>
            </a:extLst>
          </p:cNvPr>
          <p:cNvCxnSpPr>
            <a:cxnSpLocks/>
            <a:stCxn id="13" idx="3"/>
          </p:cNvCxnSpPr>
          <p:nvPr/>
        </p:nvCxnSpPr>
        <p:spPr>
          <a:xfrm flipV="1">
            <a:off x="8035493" y="4989479"/>
            <a:ext cx="437272" cy="70387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934614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F9671E2-9FD0-7925-CDD6-4D126467B1D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C4680-F7D9-29EF-15FF-CD8FEFFF71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Catheterization: Intervention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E39526F4-7DAD-ED01-79DD-848B679D00F3}"/>
              </a:ext>
            </a:extLst>
          </p:cNvPr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The right ventricle is rapidly paced using the Safari guidewire</a:t>
            </a:r>
          </a:p>
          <a:p>
            <a:r>
              <a:rPr lang="en-US" dirty="0"/>
              <a:t>The Melody Valve and bare metal stent are expanded to 22 mm</a:t>
            </a:r>
          </a:p>
        </p:txBody>
      </p:sp>
      <p:pic>
        <p:nvPicPr>
          <p:cNvPr id="6" name="Content Placeholder 5">
            <a:extLst>
              <a:ext uri="{FF2B5EF4-FFF2-40B4-BE49-F238E27FC236}">
                <a16:creationId xmlns:a16="http://schemas.microsoft.com/office/drawing/2014/main" id="{757A0B1F-1FD7-FFED-3B53-3C00C49D0629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2"/>
          <a:stretch>
            <a:fillRect/>
          </a:stretch>
        </p:blipFill>
        <p:spPr>
          <a:xfrm>
            <a:off x="6596956" y="1690688"/>
            <a:ext cx="5027746" cy="5027746"/>
          </a:xfrm>
        </p:spPr>
      </p:pic>
    </p:spTree>
    <p:extLst>
      <p:ext uri="{BB962C8B-B14F-4D97-AF65-F5344CB8AC3E}">
        <p14:creationId xmlns:p14="http://schemas.microsoft.com/office/powerpoint/2010/main" val="26019743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8FB27-7242-8CD0-9334-DF3C90D007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0793" y="0"/>
            <a:ext cx="10515600" cy="1325563"/>
          </a:xfrm>
        </p:spPr>
        <p:txBody>
          <a:bodyPr>
            <a:noAutofit/>
          </a:bodyPr>
          <a:lstStyle/>
          <a:p>
            <a:r>
              <a:rPr lang="en-US" sz="3200" dirty="0"/>
              <a:t>Post Intervention: The Melody Valve is well-seated and the neo-aortic valve leaflets are bridged and there is no neo-aortic valve regurgitation</a:t>
            </a:r>
          </a:p>
        </p:txBody>
      </p:sp>
      <p:pic>
        <p:nvPicPr>
          <p:cNvPr id="6" name="Picture 5" descr="An x-ray of a person's body&#10;&#10;AI-generated content may be incorrect.">
            <a:extLst>
              <a:ext uri="{FF2B5EF4-FFF2-40B4-BE49-F238E27FC236}">
                <a16:creationId xmlns:a16="http://schemas.microsoft.com/office/drawing/2014/main" id="{EDE6122B-B3DC-5D35-43C9-7E59FFB40E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8430" y="1320774"/>
            <a:ext cx="5941522" cy="5281353"/>
          </a:xfrm>
          <a:prstGeom prst="rect">
            <a:avLst/>
          </a:prstGeom>
        </p:spPr>
      </p:pic>
      <p:pic>
        <p:nvPicPr>
          <p:cNvPr id="8" name="Picture 7" descr="A x-ray of a heart&#10;&#10;AI-generated content may be incorrect.">
            <a:extLst>
              <a:ext uri="{FF2B5EF4-FFF2-40B4-BE49-F238E27FC236}">
                <a16:creationId xmlns:a16="http://schemas.microsoft.com/office/drawing/2014/main" id="{FBB0E072-81DA-9E87-A2FB-7356D7FD7A2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933" y="1320775"/>
            <a:ext cx="5295207" cy="52813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5848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8</TotalTime>
  <Words>166</Words>
  <Application>Microsoft Office PowerPoint</Application>
  <PresentationFormat>Widescreen</PresentationFormat>
  <Paragraphs>1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Cardiac CT: thickened neo-aortic valve leaflets with limited systolic opening.  The neo-aortic graft is 18 mm in diameter</vt:lpstr>
      <vt:lpstr>Catheterization: Aortogram Showing Hemashield Neo-Aortic Graft that Measures 15-17 mm and Thickened Neo-Aortic Valve Leaflets </vt:lpstr>
      <vt:lpstr>Catheterization: Intervention</vt:lpstr>
      <vt:lpstr>Catheterization: Intervention</vt:lpstr>
      <vt:lpstr>Post Intervention: The Melody Valve is well-seated and the neo-aortic valve leaflets are bridged and there is no neo-aortic valve regurgi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chwartz, Matthew C</dc:creator>
  <cp:lastModifiedBy>Schwartz, Matthew C</cp:lastModifiedBy>
  <cp:revision>17</cp:revision>
  <dcterms:created xsi:type="dcterms:W3CDTF">2023-05-19T15:51:29Z</dcterms:created>
  <dcterms:modified xsi:type="dcterms:W3CDTF">2025-06-04T17:59:07Z</dcterms:modified>
</cp:coreProperties>
</file>